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2192000" cy="7415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59" autoAdjust="0"/>
    <p:restoredTop sz="92634" autoAdjust="0"/>
  </p:normalViewPr>
  <p:slideViewPr>
    <p:cSldViewPr snapToGrid="0">
      <p:cViewPr varScale="1">
        <p:scale>
          <a:sx n="59" d="100"/>
          <a:sy n="59" d="100"/>
        </p:scale>
        <p:origin x="10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p\AppData\Roaming\Microsoft\Excel\Statistiques_V02%20(version%201).xlsb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p\AppData\Roaming\Microsoft\Excel\Statistiques_V02%20(version%201).xlsb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p\AppData\Roaming\Microsoft\Excel\Statistiques_V02%20(version%201).xlsb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th&#232;se\PRATIQUE\Papier%20tt\Statistiques_V0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noProof="0" dirty="0"/>
              <a:t>Tap water and well </a:t>
            </a:r>
            <a:r>
              <a:rPr lang="en-US" sz="1200" noProof="0" dirty="0" err="1"/>
              <a:t>water_Gnf</a:t>
            </a:r>
            <a:r>
              <a:rPr lang="en-US" sz="1200" noProof="0" dirty="0"/>
              <a:t>-GNB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3!$A$79</c:f>
              <c:strCache>
                <c:ptCount val="1"/>
                <c:pt idx="0">
                  <c:v>Resista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B$78:$O$78</c:f>
              <c:strCache>
                <c:ptCount val="14"/>
                <c:pt idx="0">
                  <c:v>TIC</c:v>
                </c:pt>
                <c:pt idx="1">
                  <c:v>TIM</c:v>
                </c:pt>
                <c:pt idx="2">
                  <c:v> RPL</c:v>
                </c:pt>
                <c:pt idx="3">
                  <c:v>TPZ</c:v>
                </c:pt>
                <c:pt idx="4">
                  <c:v>CAZ</c:v>
                </c:pt>
                <c:pt idx="5">
                  <c:v> FEP</c:v>
                </c:pt>
                <c:pt idx="6">
                  <c:v>ATM</c:v>
                </c:pt>
                <c:pt idx="7">
                  <c:v>IPM</c:v>
                </c:pt>
                <c:pt idx="8">
                  <c:v>TOB</c:v>
                </c:pt>
                <c:pt idx="9">
                  <c:v>CN</c:v>
                </c:pt>
                <c:pt idx="10">
                  <c:v>AK</c:v>
                </c:pt>
                <c:pt idx="11">
                  <c:v>CIP</c:v>
                </c:pt>
                <c:pt idx="12">
                  <c:v>SXT</c:v>
                </c:pt>
                <c:pt idx="13">
                  <c:v>CT</c:v>
                </c:pt>
              </c:strCache>
            </c:strRef>
          </c:cat>
          <c:val>
            <c:numRef>
              <c:f>Feuil3!$B$79:$O$79</c:f>
              <c:numCache>
                <c:formatCode>General</c:formatCode>
                <c:ptCount val="14"/>
                <c:pt idx="0">
                  <c:v>92</c:v>
                </c:pt>
                <c:pt idx="1">
                  <c:v>60</c:v>
                </c:pt>
                <c:pt idx="2">
                  <c:v>17</c:v>
                </c:pt>
                <c:pt idx="3">
                  <c:v>8</c:v>
                </c:pt>
                <c:pt idx="4">
                  <c:v>15</c:v>
                </c:pt>
                <c:pt idx="5">
                  <c:v>8</c:v>
                </c:pt>
                <c:pt idx="6">
                  <c:v>18</c:v>
                </c:pt>
                <c:pt idx="7">
                  <c:v>24</c:v>
                </c:pt>
                <c:pt idx="8">
                  <c:v>11</c:v>
                </c:pt>
                <c:pt idx="9">
                  <c:v>11</c:v>
                </c:pt>
                <c:pt idx="10">
                  <c:v>5</c:v>
                </c:pt>
                <c:pt idx="11">
                  <c:v>5</c:v>
                </c:pt>
                <c:pt idx="12">
                  <c:v>175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4C-469F-AA62-A227C1497251}"/>
            </c:ext>
          </c:extLst>
        </c:ser>
        <c:ser>
          <c:idx val="1"/>
          <c:order val="1"/>
          <c:tx>
            <c:strRef>
              <c:f>Feuil3!$A$80</c:f>
              <c:strCache>
                <c:ptCount val="1"/>
                <c:pt idx="0">
                  <c:v>Intermediat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B$78:$O$78</c:f>
              <c:strCache>
                <c:ptCount val="14"/>
                <c:pt idx="0">
                  <c:v>TIC</c:v>
                </c:pt>
                <c:pt idx="1">
                  <c:v>TIM</c:v>
                </c:pt>
                <c:pt idx="2">
                  <c:v> RPL</c:v>
                </c:pt>
                <c:pt idx="3">
                  <c:v>TPZ</c:v>
                </c:pt>
                <c:pt idx="4">
                  <c:v>CAZ</c:v>
                </c:pt>
                <c:pt idx="5">
                  <c:v> FEP</c:v>
                </c:pt>
                <c:pt idx="6">
                  <c:v>ATM</c:v>
                </c:pt>
                <c:pt idx="7">
                  <c:v>IPM</c:v>
                </c:pt>
                <c:pt idx="8">
                  <c:v>TOB</c:v>
                </c:pt>
                <c:pt idx="9">
                  <c:v>CN</c:v>
                </c:pt>
                <c:pt idx="10">
                  <c:v>AK</c:v>
                </c:pt>
                <c:pt idx="11">
                  <c:v>CIP</c:v>
                </c:pt>
                <c:pt idx="12">
                  <c:v>SXT</c:v>
                </c:pt>
                <c:pt idx="13">
                  <c:v>CT</c:v>
                </c:pt>
              </c:strCache>
            </c:strRef>
          </c:cat>
          <c:val>
            <c:numRef>
              <c:f>Feuil3!$B$80:$O$80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6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D4C-469F-AA62-A227C1497251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92061304"/>
        <c:axId val="492061960"/>
      </c:barChart>
      <c:catAx>
        <c:axId val="4920613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Antibiotic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492061960"/>
        <c:crosses val="autoZero"/>
        <c:auto val="1"/>
        <c:lblAlgn val="ctr"/>
        <c:lblOffset val="100"/>
        <c:noMultiLvlLbl val="0"/>
      </c:catAx>
      <c:valAx>
        <c:axId val="4920619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/>
                  <a:t>Numbe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4920613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/>
              <a:t>Wastewater_Enterobacteria and Aeromonad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3!$A$64</c:f>
              <c:strCache>
                <c:ptCount val="1"/>
                <c:pt idx="0">
                  <c:v>Resista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B$63:$O$63</c:f>
              <c:strCache>
                <c:ptCount val="14"/>
                <c:pt idx="0">
                  <c:v>AMC</c:v>
                </c:pt>
                <c:pt idx="1">
                  <c:v>FOX</c:v>
                </c:pt>
                <c:pt idx="2">
                  <c:v>CTX </c:v>
                </c:pt>
                <c:pt idx="3">
                  <c:v>CAZ</c:v>
                </c:pt>
                <c:pt idx="4">
                  <c:v>FEP </c:v>
                </c:pt>
                <c:pt idx="5">
                  <c:v>ATM </c:v>
                </c:pt>
                <c:pt idx="6">
                  <c:v>ETP</c:v>
                </c:pt>
                <c:pt idx="7">
                  <c:v>IPM</c:v>
                </c:pt>
                <c:pt idx="8">
                  <c:v>TOB</c:v>
                </c:pt>
                <c:pt idx="9">
                  <c:v>CN</c:v>
                </c:pt>
                <c:pt idx="10">
                  <c:v>AK</c:v>
                </c:pt>
                <c:pt idx="11">
                  <c:v>CIP</c:v>
                </c:pt>
                <c:pt idx="12">
                  <c:v>SXT</c:v>
                </c:pt>
                <c:pt idx="13">
                  <c:v>CT</c:v>
                </c:pt>
              </c:strCache>
            </c:strRef>
          </c:cat>
          <c:val>
            <c:numRef>
              <c:f>Feuil3!$B$64:$O$64</c:f>
              <c:numCache>
                <c:formatCode>General</c:formatCode>
                <c:ptCount val="14"/>
                <c:pt idx="0">
                  <c:v>61</c:v>
                </c:pt>
                <c:pt idx="1">
                  <c:v>53</c:v>
                </c:pt>
                <c:pt idx="2">
                  <c:v>54</c:v>
                </c:pt>
                <c:pt idx="3">
                  <c:v>53</c:v>
                </c:pt>
                <c:pt idx="4">
                  <c:v>46</c:v>
                </c:pt>
                <c:pt idx="5">
                  <c:v>41</c:v>
                </c:pt>
                <c:pt idx="6">
                  <c:v>59</c:v>
                </c:pt>
                <c:pt idx="7">
                  <c:v>23</c:v>
                </c:pt>
                <c:pt idx="8">
                  <c:v>28</c:v>
                </c:pt>
                <c:pt idx="9">
                  <c:v>39</c:v>
                </c:pt>
                <c:pt idx="10">
                  <c:v>7</c:v>
                </c:pt>
                <c:pt idx="11">
                  <c:v>54</c:v>
                </c:pt>
                <c:pt idx="12">
                  <c:v>57</c:v>
                </c:pt>
                <c:pt idx="13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5F5-4239-9FC8-89DAD835C64F}"/>
            </c:ext>
          </c:extLst>
        </c:ser>
        <c:ser>
          <c:idx val="1"/>
          <c:order val="1"/>
          <c:tx>
            <c:strRef>
              <c:f>Feuil3!$A$65</c:f>
              <c:strCache>
                <c:ptCount val="1"/>
                <c:pt idx="0">
                  <c:v>Intermediat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B$63:$O$63</c:f>
              <c:strCache>
                <c:ptCount val="14"/>
                <c:pt idx="0">
                  <c:v>AMC</c:v>
                </c:pt>
                <c:pt idx="1">
                  <c:v>FOX</c:v>
                </c:pt>
                <c:pt idx="2">
                  <c:v>CTX </c:v>
                </c:pt>
                <c:pt idx="3">
                  <c:v>CAZ</c:v>
                </c:pt>
                <c:pt idx="4">
                  <c:v>FEP </c:v>
                </c:pt>
                <c:pt idx="5">
                  <c:v>ATM </c:v>
                </c:pt>
                <c:pt idx="6">
                  <c:v>ETP</c:v>
                </c:pt>
                <c:pt idx="7">
                  <c:v>IPM</c:v>
                </c:pt>
                <c:pt idx="8">
                  <c:v>TOB</c:v>
                </c:pt>
                <c:pt idx="9">
                  <c:v>CN</c:v>
                </c:pt>
                <c:pt idx="10">
                  <c:v>AK</c:v>
                </c:pt>
                <c:pt idx="11">
                  <c:v>CIP</c:v>
                </c:pt>
                <c:pt idx="12">
                  <c:v>SXT</c:v>
                </c:pt>
                <c:pt idx="13">
                  <c:v>CT</c:v>
                </c:pt>
              </c:strCache>
            </c:strRef>
          </c:cat>
          <c:val>
            <c:numRef>
              <c:f>Feuil3!$B$65:$O$65</c:f>
              <c:numCache>
                <c:formatCode>General</c:formatCode>
                <c:ptCount val="14"/>
                <c:pt idx="0">
                  <c:v>5</c:v>
                </c:pt>
                <c:pt idx="1">
                  <c:v>0</c:v>
                </c:pt>
                <c:pt idx="2">
                  <c:v>2</c:v>
                </c:pt>
                <c:pt idx="3">
                  <c:v>1</c:v>
                </c:pt>
                <c:pt idx="4">
                  <c:v>4</c:v>
                </c:pt>
                <c:pt idx="5">
                  <c:v>6</c:v>
                </c:pt>
                <c:pt idx="6">
                  <c:v>0</c:v>
                </c:pt>
                <c:pt idx="7">
                  <c:v>6</c:v>
                </c:pt>
                <c:pt idx="8">
                  <c:v>15</c:v>
                </c:pt>
                <c:pt idx="9">
                  <c:v>6</c:v>
                </c:pt>
                <c:pt idx="10">
                  <c:v>1</c:v>
                </c:pt>
                <c:pt idx="11">
                  <c:v>3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5F5-4239-9FC8-89DAD835C64F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555315688"/>
        <c:axId val="555316016"/>
      </c:barChart>
      <c:catAx>
        <c:axId val="5553156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Antibiotic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555316016"/>
        <c:crosses val="autoZero"/>
        <c:auto val="1"/>
        <c:lblAlgn val="ctr"/>
        <c:lblOffset val="100"/>
        <c:noMultiLvlLbl val="0"/>
      </c:catAx>
      <c:valAx>
        <c:axId val="5553160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umbe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5553156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noProof="0" dirty="0" err="1"/>
              <a:t>Wastewater_Gnf</a:t>
            </a:r>
            <a:r>
              <a:rPr lang="en-US" sz="1200" noProof="0" dirty="0"/>
              <a:t>-GNB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3!$A$69</c:f>
              <c:strCache>
                <c:ptCount val="1"/>
                <c:pt idx="0">
                  <c:v>Resista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B$68:$O$68</c:f>
              <c:strCache>
                <c:ptCount val="14"/>
                <c:pt idx="0">
                  <c:v>TIC</c:v>
                </c:pt>
                <c:pt idx="1">
                  <c:v>TIM</c:v>
                </c:pt>
                <c:pt idx="2">
                  <c:v> RPL</c:v>
                </c:pt>
                <c:pt idx="3">
                  <c:v>TPZ</c:v>
                </c:pt>
                <c:pt idx="4">
                  <c:v>CAZ</c:v>
                </c:pt>
                <c:pt idx="5">
                  <c:v> FEP</c:v>
                </c:pt>
                <c:pt idx="6">
                  <c:v>ATM</c:v>
                </c:pt>
                <c:pt idx="7">
                  <c:v>IPM</c:v>
                </c:pt>
                <c:pt idx="8">
                  <c:v>TOB</c:v>
                </c:pt>
                <c:pt idx="9">
                  <c:v>CN</c:v>
                </c:pt>
                <c:pt idx="10">
                  <c:v>AK</c:v>
                </c:pt>
                <c:pt idx="11">
                  <c:v>CIP</c:v>
                </c:pt>
                <c:pt idx="12">
                  <c:v>SXT</c:v>
                </c:pt>
                <c:pt idx="13">
                  <c:v>CT</c:v>
                </c:pt>
              </c:strCache>
            </c:strRef>
          </c:cat>
          <c:val>
            <c:numRef>
              <c:f>Feuil3!$B$69:$O$69</c:f>
              <c:numCache>
                <c:formatCode>General</c:formatCode>
                <c:ptCount val="14"/>
                <c:pt idx="0">
                  <c:v>18</c:v>
                </c:pt>
                <c:pt idx="1">
                  <c:v>15</c:v>
                </c:pt>
                <c:pt idx="2">
                  <c:v>13</c:v>
                </c:pt>
                <c:pt idx="3">
                  <c:v>9</c:v>
                </c:pt>
                <c:pt idx="4">
                  <c:v>9</c:v>
                </c:pt>
                <c:pt idx="5">
                  <c:v>9</c:v>
                </c:pt>
                <c:pt idx="6">
                  <c:v>8</c:v>
                </c:pt>
                <c:pt idx="7">
                  <c:v>16</c:v>
                </c:pt>
                <c:pt idx="8">
                  <c:v>9</c:v>
                </c:pt>
                <c:pt idx="9">
                  <c:v>9</c:v>
                </c:pt>
                <c:pt idx="10">
                  <c:v>1</c:v>
                </c:pt>
                <c:pt idx="11">
                  <c:v>10</c:v>
                </c:pt>
                <c:pt idx="12">
                  <c:v>19</c:v>
                </c:pt>
                <c:pt idx="1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09-46FD-BF15-848E3DED9C89}"/>
            </c:ext>
          </c:extLst>
        </c:ser>
        <c:ser>
          <c:idx val="1"/>
          <c:order val="1"/>
          <c:tx>
            <c:strRef>
              <c:f>Feuil3!$A$70</c:f>
              <c:strCache>
                <c:ptCount val="1"/>
                <c:pt idx="0">
                  <c:v>Intermediat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B$68:$O$68</c:f>
              <c:strCache>
                <c:ptCount val="14"/>
                <c:pt idx="0">
                  <c:v>TIC</c:v>
                </c:pt>
                <c:pt idx="1">
                  <c:v>TIM</c:v>
                </c:pt>
                <c:pt idx="2">
                  <c:v> RPL</c:v>
                </c:pt>
                <c:pt idx="3">
                  <c:v>TPZ</c:v>
                </c:pt>
                <c:pt idx="4">
                  <c:v>CAZ</c:v>
                </c:pt>
                <c:pt idx="5">
                  <c:v> FEP</c:v>
                </c:pt>
                <c:pt idx="6">
                  <c:v>ATM</c:v>
                </c:pt>
                <c:pt idx="7">
                  <c:v>IPM</c:v>
                </c:pt>
                <c:pt idx="8">
                  <c:v>TOB</c:v>
                </c:pt>
                <c:pt idx="9">
                  <c:v>CN</c:v>
                </c:pt>
                <c:pt idx="10">
                  <c:v>AK</c:v>
                </c:pt>
                <c:pt idx="11">
                  <c:v>CIP</c:v>
                </c:pt>
                <c:pt idx="12">
                  <c:v>SXT</c:v>
                </c:pt>
                <c:pt idx="13">
                  <c:v>CT</c:v>
                </c:pt>
              </c:strCache>
            </c:strRef>
          </c:cat>
          <c:val>
            <c:numRef>
              <c:f>Feuil3!$B$70:$O$70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4</c:v>
                </c:pt>
                <c:pt idx="8">
                  <c:v>0</c:v>
                </c:pt>
                <c:pt idx="9">
                  <c:v>0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709-46FD-BF15-848E3DED9C89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71149864"/>
        <c:axId val="171148224"/>
      </c:barChart>
      <c:catAx>
        <c:axId val="1711498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Antibiotic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171148224"/>
        <c:crosses val="autoZero"/>
        <c:auto val="1"/>
        <c:lblAlgn val="ctr"/>
        <c:lblOffset val="100"/>
        <c:noMultiLvlLbl val="0"/>
      </c:catAx>
      <c:valAx>
        <c:axId val="1711482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umbe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1711498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/>
              <a:t>Tap water and well water_Enterobacteria and Aeromonad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0862263509871306"/>
          <c:y val="9.6879540326998081E-2"/>
          <c:w val="0.86656522759230448"/>
          <c:h val="0.6785186462505733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3!$A$74</c:f>
              <c:strCache>
                <c:ptCount val="1"/>
                <c:pt idx="0">
                  <c:v>Resista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B$73:$O$73</c:f>
              <c:strCache>
                <c:ptCount val="14"/>
                <c:pt idx="0">
                  <c:v>AMC</c:v>
                </c:pt>
                <c:pt idx="1">
                  <c:v>KF</c:v>
                </c:pt>
                <c:pt idx="2">
                  <c:v>CRO </c:v>
                </c:pt>
                <c:pt idx="3">
                  <c:v>CAZ </c:v>
                </c:pt>
                <c:pt idx="4">
                  <c:v>FEP </c:v>
                </c:pt>
                <c:pt idx="5">
                  <c:v>ATM </c:v>
                </c:pt>
                <c:pt idx="6">
                  <c:v>ETP </c:v>
                </c:pt>
                <c:pt idx="7">
                  <c:v>IPM</c:v>
                </c:pt>
                <c:pt idx="8">
                  <c:v>TOB</c:v>
                </c:pt>
                <c:pt idx="9">
                  <c:v>CN</c:v>
                </c:pt>
                <c:pt idx="10">
                  <c:v>AK</c:v>
                </c:pt>
                <c:pt idx="11">
                  <c:v>CIP</c:v>
                </c:pt>
                <c:pt idx="12">
                  <c:v>SXT</c:v>
                </c:pt>
                <c:pt idx="13">
                  <c:v>CT</c:v>
                </c:pt>
              </c:strCache>
            </c:strRef>
          </c:cat>
          <c:val>
            <c:numRef>
              <c:f>Feuil3!$B$74:$O$74</c:f>
              <c:numCache>
                <c:formatCode>General</c:formatCode>
                <c:ptCount val="14"/>
                <c:pt idx="0">
                  <c:v>69</c:v>
                </c:pt>
                <c:pt idx="1">
                  <c:v>86</c:v>
                </c:pt>
                <c:pt idx="2">
                  <c:v>2</c:v>
                </c:pt>
                <c:pt idx="3">
                  <c:v>7</c:v>
                </c:pt>
                <c:pt idx="4">
                  <c:v>1</c:v>
                </c:pt>
                <c:pt idx="5">
                  <c:v>2</c:v>
                </c:pt>
                <c:pt idx="6">
                  <c:v>2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0</c:v>
                </c:pt>
                <c:pt idx="11">
                  <c:v>1</c:v>
                </c:pt>
                <c:pt idx="12">
                  <c:v>10</c:v>
                </c:pt>
                <c:pt idx="13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57-4477-A265-766E92B70CA6}"/>
            </c:ext>
          </c:extLst>
        </c:ser>
        <c:ser>
          <c:idx val="1"/>
          <c:order val="1"/>
          <c:tx>
            <c:strRef>
              <c:f>Feuil3!$A$75</c:f>
              <c:strCache>
                <c:ptCount val="1"/>
                <c:pt idx="0">
                  <c:v>Intermediat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B$73:$O$73</c:f>
              <c:strCache>
                <c:ptCount val="14"/>
                <c:pt idx="0">
                  <c:v>AMC</c:v>
                </c:pt>
                <c:pt idx="1">
                  <c:v>KF</c:v>
                </c:pt>
                <c:pt idx="2">
                  <c:v>CRO </c:v>
                </c:pt>
                <c:pt idx="3">
                  <c:v>CAZ </c:v>
                </c:pt>
                <c:pt idx="4">
                  <c:v>FEP </c:v>
                </c:pt>
                <c:pt idx="5">
                  <c:v>ATM </c:v>
                </c:pt>
                <c:pt idx="6">
                  <c:v>ETP </c:v>
                </c:pt>
                <c:pt idx="7">
                  <c:v>IPM</c:v>
                </c:pt>
                <c:pt idx="8">
                  <c:v>TOB</c:v>
                </c:pt>
                <c:pt idx="9">
                  <c:v>CN</c:v>
                </c:pt>
                <c:pt idx="10">
                  <c:v>AK</c:v>
                </c:pt>
                <c:pt idx="11">
                  <c:v>CIP</c:v>
                </c:pt>
                <c:pt idx="12">
                  <c:v>SXT</c:v>
                </c:pt>
                <c:pt idx="13">
                  <c:v>CT</c:v>
                </c:pt>
              </c:strCache>
            </c:strRef>
          </c:cat>
          <c:val>
            <c:numRef>
              <c:f>Feuil3!$B$75:$O$75</c:f>
              <c:numCache>
                <c:formatCode>General</c:formatCode>
                <c:ptCount val="14"/>
                <c:pt idx="0">
                  <c:v>8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C57-4477-A265-766E92B70CA6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66832448"/>
        <c:axId val="466832120"/>
      </c:barChart>
      <c:catAx>
        <c:axId val="4668324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Antibiotic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466832120"/>
        <c:crosses val="autoZero"/>
        <c:auto val="1"/>
        <c:lblAlgn val="ctr"/>
        <c:lblOffset val="100"/>
        <c:noMultiLvlLbl val="0"/>
      </c:catAx>
      <c:valAx>
        <c:axId val="4668321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umbe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4668324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D98174-CD29-4FEA-A797-6658325D21D3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892175" y="1143000"/>
            <a:ext cx="5073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A6328-88B2-4F5E-9503-DDAAE159004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71236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892175" y="1143000"/>
            <a:ext cx="5073650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4A6328-88B2-4F5E-9503-DDAAE159004A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44968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213555"/>
            <a:ext cx="9144000" cy="258159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894704"/>
            <a:ext cx="9144000" cy="179029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2037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33893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94792"/>
            <a:ext cx="2628900" cy="6284050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94792"/>
            <a:ext cx="7734300" cy="628405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3104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5432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848655"/>
            <a:ext cx="10515600" cy="308452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962358"/>
            <a:ext cx="10515600" cy="162207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8921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973957"/>
            <a:ext cx="5181600" cy="470488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973957"/>
            <a:ext cx="5181600" cy="470488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1939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94792"/>
            <a:ext cx="10515600" cy="143326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817758"/>
            <a:ext cx="5157787" cy="8908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708613"/>
            <a:ext cx="5157787" cy="398396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817758"/>
            <a:ext cx="5183188" cy="8908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708613"/>
            <a:ext cx="5183188" cy="398396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0491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8072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0611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94348"/>
            <a:ext cx="3932237" cy="1730216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067654"/>
            <a:ext cx="6172200" cy="526960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224564"/>
            <a:ext cx="3932237" cy="412128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8918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94348"/>
            <a:ext cx="3932237" cy="1730216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067654"/>
            <a:ext cx="6172200" cy="526960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224564"/>
            <a:ext cx="3932237" cy="412128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3114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94792"/>
            <a:ext cx="10515600" cy="14332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973957"/>
            <a:ext cx="10515600" cy="47048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872805"/>
            <a:ext cx="2743200" cy="3947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45106F-316E-48F0-8ED6-2E0C46DCBAD2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872805"/>
            <a:ext cx="4114800" cy="3947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872805"/>
            <a:ext cx="2743200" cy="3947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3A6C7-C96A-4BE9-BE2E-7D85C75898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5122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C2062B62-3989-4185-B72C-145F250C3DC6}"/>
              </a:ext>
            </a:extLst>
          </p:cNvPr>
          <p:cNvGrpSpPr/>
          <p:nvPr/>
        </p:nvGrpSpPr>
        <p:grpSpPr>
          <a:xfrm>
            <a:off x="232844" y="183001"/>
            <a:ext cx="11726312" cy="6533322"/>
            <a:chOff x="232844" y="165652"/>
            <a:chExt cx="11726312" cy="6533322"/>
          </a:xfrm>
        </p:grpSpPr>
        <p:graphicFrame>
          <p:nvGraphicFramePr>
            <p:cNvPr id="5" name="Graphique 4">
              <a:extLst>
                <a:ext uri="{FF2B5EF4-FFF2-40B4-BE49-F238E27FC236}">
                  <a16:creationId xmlns:a16="http://schemas.microsoft.com/office/drawing/2014/main" id="{91507F56-CD53-4217-B8F7-A3E940ABA8C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44169303"/>
                </p:ext>
              </p:extLst>
            </p:nvPr>
          </p:nvGraphicFramePr>
          <p:xfrm>
            <a:off x="6228523" y="272290"/>
            <a:ext cx="5630311" cy="31567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Graphique 5">
              <a:extLst>
                <a:ext uri="{FF2B5EF4-FFF2-40B4-BE49-F238E27FC236}">
                  <a16:creationId xmlns:a16="http://schemas.microsoft.com/office/drawing/2014/main" id="{05D5311C-6E0C-4725-BAE1-79D9136944D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38174336"/>
                </p:ext>
              </p:extLst>
            </p:nvPr>
          </p:nvGraphicFramePr>
          <p:xfrm>
            <a:off x="333166" y="3561522"/>
            <a:ext cx="5630310" cy="30241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Graphique 6">
              <a:extLst>
                <a:ext uri="{FF2B5EF4-FFF2-40B4-BE49-F238E27FC236}">
                  <a16:creationId xmlns:a16="http://schemas.microsoft.com/office/drawing/2014/main" id="{29E1276B-9328-4EE2-A57B-DED04DD4C1B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27657344"/>
                </p:ext>
              </p:extLst>
            </p:nvPr>
          </p:nvGraphicFramePr>
          <p:xfrm>
            <a:off x="6228524" y="3561522"/>
            <a:ext cx="5630310" cy="30241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D6388CC9-432F-40E4-A5CD-C677F88E8C86}"/>
                </a:ext>
              </a:extLst>
            </p:cNvPr>
            <p:cNvSpPr/>
            <p:nvPr/>
          </p:nvSpPr>
          <p:spPr>
            <a:xfrm>
              <a:off x="232844" y="165652"/>
              <a:ext cx="11726312" cy="653332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8294E039-0525-4F08-B58C-D935D1A84C32}"/>
                </a:ext>
              </a:extLst>
            </p:cNvPr>
            <p:cNvSpPr txBox="1"/>
            <p:nvPr/>
          </p:nvSpPr>
          <p:spPr>
            <a:xfrm>
              <a:off x="383327" y="312019"/>
              <a:ext cx="461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38B401C5-3865-4EEA-9CF3-1A1FE691F151}"/>
                </a:ext>
              </a:extLst>
            </p:cNvPr>
            <p:cNvSpPr txBox="1"/>
            <p:nvPr/>
          </p:nvSpPr>
          <p:spPr>
            <a:xfrm>
              <a:off x="6318438" y="3650671"/>
              <a:ext cx="461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5A7833CC-800D-464A-852F-05FD1478E50F}"/>
                </a:ext>
              </a:extLst>
            </p:cNvPr>
            <p:cNvSpPr txBox="1"/>
            <p:nvPr/>
          </p:nvSpPr>
          <p:spPr>
            <a:xfrm>
              <a:off x="380479" y="3651567"/>
              <a:ext cx="461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329554FA-E466-457B-A06B-2B5DC3A975C6}"/>
                </a:ext>
              </a:extLst>
            </p:cNvPr>
            <p:cNvSpPr txBox="1"/>
            <p:nvPr/>
          </p:nvSpPr>
          <p:spPr>
            <a:xfrm>
              <a:off x="6318438" y="309042"/>
              <a:ext cx="4619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graphicFrame>
          <p:nvGraphicFramePr>
            <p:cNvPr id="13" name="Graphique 12">
              <a:extLst>
                <a:ext uri="{FF2B5EF4-FFF2-40B4-BE49-F238E27FC236}">
                  <a16:creationId xmlns:a16="http://schemas.microsoft.com/office/drawing/2014/main" id="{7D30CFA2-006A-45BD-9E8D-BF2D0D233BC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30024137"/>
                </p:ext>
              </p:extLst>
            </p:nvPr>
          </p:nvGraphicFramePr>
          <p:xfrm>
            <a:off x="333166" y="272291"/>
            <a:ext cx="5630309" cy="31567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sp>
        <p:nvSpPr>
          <p:cNvPr id="14" name="ZoneTexte 13">
            <a:extLst>
              <a:ext uri="{FF2B5EF4-FFF2-40B4-BE49-F238E27FC236}">
                <a16:creationId xmlns:a16="http://schemas.microsoft.com/office/drawing/2014/main" id="{8BB65547-A404-4CEE-97CD-DD13077A9226}"/>
              </a:ext>
            </a:extLst>
          </p:cNvPr>
          <p:cNvSpPr txBox="1"/>
          <p:nvPr/>
        </p:nvSpPr>
        <p:spPr>
          <a:xfrm>
            <a:off x="333166" y="6805472"/>
            <a:ext cx="1162599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12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.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.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tibiogram results. AK, amikacin; AMC, amoxicillin/ clavulanate; ATM, aztreonam; CAZ, ceftazidime; CIP, ciprofloxacin; CN, gentamicin; CTX, cefotaxime; CT, colistin; ETP, ertapenem; FEP, cefepime; I, intermediate; IPM, imipenem; KF,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efalotin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R, resistant; S, susceptible; SXT, cotrimoxazole; TOB, tobramycin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080022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88</TotalTime>
  <Words>114</Words>
  <Application>Microsoft Office PowerPoint</Application>
  <PresentationFormat>Personnalisé</PresentationFormat>
  <Paragraphs>18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p</dc:creator>
  <cp:lastModifiedBy>hp</cp:lastModifiedBy>
  <cp:revision>12</cp:revision>
  <dcterms:created xsi:type="dcterms:W3CDTF">2021-07-25T18:00:46Z</dcterms:created>
  <dcterms:modified xsi:type="dcterms:W3CDTF">2022-04-05T22:03:55Z</dcterms:modified>
</cp:coreProperties>
</file>